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3" r:id="rId2"/>
    <p:sldId id="266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516" y="22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2C05DB-7FF2-49E0-85FC-EE7E78EAF8B2}" type="datetimeFigureOut">
              <a:rPr lang="en-AU" smtClean="0"/>
              <a:t>29/09/2014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D11B5C-7968-4128-ABF8-E3076A41D58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123742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E64AE-63B9-4A67-B9D6-9AE8EE653748}" type="datetimeFigureOut">
              <a:rPr lang="en-AU" smtClean="0"/>
              <a:t>29/09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339A-9EEB-4A48-ADBF-0629FF6D3D0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88028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E64AE-63B9-4A67-B9D6-9AE8EE653748}" type="datetimeFigureOut">
              <a:rPr lang="en-AU" smtClean="0"/>
              <a:t>29/09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339A-9EEB-4A48-ADBF-0629FF6D3D0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22480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E64AE-63B9-4A67-B9D6-9AE8EE653748}" type="datetimeFigureOut">
              <a:rPr lang="en-AU" smtClean="0"/>
              <a:t>29/09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339A-9EEB-4A48-ADBF-0629FF6D3D0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090202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E64AE-63B9-4A67-B9D6-9AE8EE653748}" type="datetimeFigureOut">
              <a:rPr lang="en-AU" smtClean="0"/>
              <a:t>29/09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339A-9EEB-4A48-ADBF-0629FF6D3D0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76543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E64AE-63B9-4A67-B9D6-9AE8EE653748}" type="datetimeFigureOut">
              <a:rPr lang="en-AU" smtClean="0"/>
              <a:t>29/09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339A-9EEB-4A48-ADBF-0629FF6D3D0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49574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E64AE-63B9-4A67-B9D6-9AE8EE653748}" type="datetimeFigureOut">
              <a:rPr lang="en-AU" smtClean="0"/>
              <a:t>29/09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339A-9EEB-4A48-ADBF-0629FF6D3D0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670923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E64AE-63B9-4A67-B9D6-9AE8EE653748}" type="datetimeFigureOut">
              <a:rPr lang="en-AU" smtClean="0"/>
              <a:t>29/09/2014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339A-9EEB-4A48-ADBF-0629FF6D3D0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92863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E64AE-63B9-4A67-B9D6-9AE8EE653748}" type="datetimeFigureOut">
              <a:rPr lang="en-AU" smtClean="0"/>
              <a:t>29/09/2014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339A-9EEB-4A48-ADBF-0629FF6D3D0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0335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E64AE-63B9-4A67-B9D6-9AE8EE653748}" type="datetimeFigureOut">
              <a:rPr lang="en-AU" smtClean="0"/>
              <a:t>29/09/2014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339A-9EEB-4A48-ADBF-0629FF6D3D0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91017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E64AE-63B9-4A67-B9D6-9AE8EE653748}" type="datetimeFigureOut">
              <a:rPr lang="en-AU" smtClean="0"/>
              <a:t>29/09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339A-9EEB-4A48-ADBF-0629FF6D3D0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27203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E64AE-63B9-4A67-B9D6-9AE8EE653748}" type="datetimeFigureOut">
              <a:rPr lang="en-AU" smtClean="0"/>
              <a:t>29/09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8339A-9EEB-4A48-ADBF-0629FF6D3D0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61089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4E64AE-63B9-4A67-B9D6-9AE8EE653748}" type="datetimeFigureOut">
              <a:rPr lang="en-AU" smtClean="0"/>
              <a:t>29/09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78339A-9EEB-4A48-ADBF-0629FF6D3D0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60893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8083" y="219264"/>
            <a:ext cx="14734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S1</a:t>
            </a:r>
          </a:p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padhyaya NM et al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17382" y="6835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23794" y="337922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260648" y="827584"/>
            <a:ext cx="6008241" cy="6807661"/>
            <a:chOff x="260648" y="827584"/>
            <a:chExt cx="6008241" cy="6807661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84784" y="827584"/>
              <a:ext cx="3672408" cy="2202468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0227" y="3203848"/>
              <a:ext cx="4405246" cy="3384376"/>
            </a:xfrm>
            <a:prstGeom prst="rect">
              <a:avLst/>
            </a:prstGeom>
          </p:spPr>
        </p:pic>
        <p:sp>
          <p:nvSpPr>
            <p:cNvPr id="10" name="Rectangle 9"/>
            <p:cNvSpPr/>
            <p:nvPr/>
          </p:nvSpPr>
          <p:spPr>
            <a:xfrm>
              <a:off x="260648" y="6804248"/>
              <a:ext cx="6008241" cy="83099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AU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1.   A. </a:t>
              </a:r>
              <a:r>
                <a:rPr lang="en-AU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AU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tribution of BLAST2GO three-step processes including Blastp, mapping and annotation of the predicted gene set of </a:t>
              </a:r>
              <a:r>
                <a:rPr lang="en-AU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gt</a:t>
              </a:r>
              <a:r>
                <a:rPr lang="en-AU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en-AU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lang="en-AU" sz="1200" b="1" dirty="0" smtClean="0"/>
                <a:t>B. </a:t>
              </a:r>
              <a:r>
                <a:rPr lang="en-AU" sz="1200" dirty="0"/>
                <a:t>Species distribution by accounting all BLASTX hits in the </a:t>
              </a:r>
              <a:r>
                <a:rPr lang="en-AU" sz="1200" i="1" dirty="0"/>
                <a:t>Pgt</a:t>
              </a:r>
              <a:r>
                <a:rPr lang="en-AU" sz="1200" dirty="0"/>
                <a:t> predicted gene set.</a:t>
              </a:r>
              <a:r>
                <a:rPr lang="en-AU" sz="1200" b="1" dirty="0"/>
                <a:t> </a:t>
              </a:r>
              <a:r>
                <a:rPr lang="en-AU" sz="1200" dirty="0"/>
                <a:t>The top five species are all </a:t>
              </a:r>
              <a:r>
                <a:rPr lang="en-AU" sz="1200" dirty="0" err="1"/>
                <a:t>Basidiomycota</a:t>
              </a:r>
              <a:r>
                <a:rPr lang="en-AU" sz="1200" dirty="0"/>
                <a:t> and two of them fungal pathogens</a:t>
              </a:r>
              <a:r>
                <a:rPr lang="en-AU" sz="1200" dirty="0" smtClean="0"/>
                <a:t>.</a:t>
              </a:r>
              <a:endParaRPr lang="en-AU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14173710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85939" y="5004048"/>
            <a:ext cx="583601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nn diagram showing percentage of shared non-synonymous polymorphisms in the </a:t>
            </a:r>
            <a:r>
              <a:rPr lang="en-AU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6</a:t>
            </a:r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of 520)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s genes between the four Australian founder isolates, 21-0, 126, 194 and 326.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236949" y="107504"/>
            <a:ext cx="14734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2</a:t>
            </a:r>
          </a:p>
          <a:p>
            <a:r>
              <a:rPr lang="en-AU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padhyaya NM et al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8" name="Group 37"/>
          <p:cNvGrpSpPr/>
          <p:nvPr/>
        </p:nvGrpSpPr>
        <p:grpSpPr>
          <a:xfrm>
            <a:off x="1710429" y="1452686"/>
            <a:ext cx="3374755" cy="3196050"/>
            <a:chOff x="1710429" y="1452686"/>
            <a:chExt cx="3374755" cy="3196050"/>
          </a:xfrm>
        </p:grpSpPr>
        <p:sp>
          <p:nvSpPr>
            <p:cNvPr id="41" name="Oval 40"/>
            <p:cNvSpPr/>
            <p:nvPr/>
          </p:nvSpPr>
          <p:spPr>
            <a:xfrm rot="18900000">
              <a:off x="2504505" y="1452686"/>
              <a:ext cx="1541491" cy="2348940"/>
            </a:xfrm>
            <a:prstGeom prst="ellipse">
              <a:avLst/>
            </a:prstGeom>
            <a:solidFill>
              <a:schemeClr val="accent1">
                <a:alpha val="43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200"/>
            </a:p>
          </p:txBody>
        </p:sp>
        <p:sp>
          <p:nvSpPr>
            <p:cNvPr id="42" name="Oval 41"/>
            <p:cNvSpPr/>
            <p:nvPr/>
          </p:nvSpPr>
          <p:spPr>
            <a:xfrm rot="2700000">
              <a:off x="2976615" y="2094278"/>
              <a:ext cx="1541492" cy="2348939"/>
            </a:xfrm>
            <a:prstGeom prst="ellipse">
              <a:avLst/>
            </a:prstGeom>
            <a:solidFill>
              <a:srgbClr val="FF0000">
                <a:alpha val="43000"/>
              </a:srgb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200"/>
            </a:p>
          </p:txBody>
        </p:sp>
        <p:sp>
          <p:nvSpPr>
            <p:cNvPr id="43" name="Oval 42"/>
            <p:cNvSpPr/>
            <p:nvPr/>
          </p:nvSpPr>
          <p:spPr>
            <a:xfrm rot="2700000">
              <a:off x="2622376" y="1452687"/>
              <a:ext cx="1541492" cy="2348939"/>
            </a:xfrm>
            <a:prstGeom prst="ellipse">
              <a:avLst/>
            </a:prstGeom>
            <a:solidFill>
              <a:srgbClr val="7030A0">
                <a:alpha val="43000"/>
              </a:srgb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200" dirty="0"/>
            </a:p>
          </p:txBody>
        </p:sp>
        <p:sp>
          <p:nvSpPr>
            <p:cNvPr id="44" name="Oval 43"/>
            <p:cNvSpPr/>
            <p:nvPr/>
          </p:nvSpPr>
          <p:spPr>
            <a:xfrm rot="18900000">
              <a:off x="2185746" y="2090203"/>
              <a:ext cx="1541491" cy="2348940"/>
            </a:xfrm>
            <a:prstGeom prst="ellipse">
              <a:avLst/>
            </a:prstGeom>
            <a:solidFill>
              <a:srgbClr val="00B050">
                <a:alpha val="43000"/>
              </a:srgb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20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571902" y="3275856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 smtClean="0"/>
                <a:t>21-0</a:t>
              </a:r>
              <a:endParaRPr lang="en-AU" sz="1400" b="1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083638" y="3019007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477</a:t>
              </a:r>
              <a:endParaRPr lang="en-AU" sz="12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062603" y="1475656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 smtClean="0"/>
                <a:t>126</a:t>
              </a:r>
              <a:endParaRPr lang="en-AU" sz="1400" b="1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192158" y="1475656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 smtClean="0"/>
                <a:t>326</a:t>
              </a:r>
              <a:endParaRPr lang="en-AU" sz="1400" b="1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1710429" y="3323609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b="1" dirty="0" smtClean="0"/>
                <a:t>194</a:t>
              </a:r>
              <a:endParaRPr lang="en-AU" sz="1400" b="1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708920" y="3365043"/>
              <a:ext cx="5373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,085</a:t>
              </a:r>
              <a:endParaRPr lang="en-AU" sz="12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411125" y="3116385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/>
                <a:t>25</a:t>
              </a:r>
              <a:endParaRPr lang="en-AU" sz="12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2678641" y="2626653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8</a:t>
              </a:r>
              <a:endParaRPr lang="en-AU" sz="12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2000291" y="274534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58</a:t>
              </a:r>
              <a:endParaRPr lang="en-AU" sz="12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3161796" y="3775057"/>
              <a:ext cx="5373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,415</a:t>
              </a:r>
              <a:endParaRPr lang="en-AU" sz="12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3893954" y="3076277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5</a:t>
              </a:r>
              <a:endParaRPr lang="en-AU" sz="12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246048" y="2745340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202</a:t>
              </a:r>
              <a:endParaRPr lang="en-AU" sz="12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661065" y="262435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3</a:t>
              </a:r>
              <a:endParaRPr lang="en-AU" sz="12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3089453" y="2063143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9</a:t>
              </a:r>
              <a:endParaRPr lang="en-AU" sz="12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860248" y="1836070"/>
              <a:ext cx="5373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,249</a:t>
              </a:r>
              <a:endParaRPr lang="en-AU" sz="12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484165" y="183607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/>
                <a:t>17</a:t>
              </a:r>
              <a:endParaRPr lang="en-AU" sz="1200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4060251" y="229674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61</a:t>
              </a:r>
              <a:endParaRPr lang="en-AU" sz="1200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2244913" y="229674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3</a:t>
              </a:r>
              <a:endParaRPr lang="en-AU" sz="1200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561563" y="3365042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588</a:t>
              </a:r>
              <a:endParaRPr lang="en-AU" sz="12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916832" y="4371737"/>
              <a:ext cx="30287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smtClean="0"/>
                <a:t>Combined non-synonymous variants  = </a:t>
              </a:r>
              <a:r>
                <a:rPr lang="en-AU" sz="1200" dirty="0" smtClean="0"/>
                <a:t>5,245</a:t>
              </a:r>
              <a:r>
                <a:rPr lang="en-AU" sz="1200" dirty="0" smtClean="0"/>
                <a:t> </a:t>
              </a:r>
              <a:endParaRPr lang="en-AU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6395755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2</TotalTime>
  <Words>127</Words>
  <Application>Microsoft Office PowerPoint</Application>
  <PresentationFormat>On-screen Show (4:3)</PresentationFormat>
  <Paragraphs>2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CSIR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padhyaya, Narayana (PI, Black Mountain)</dc:creator>
  <cp:lastModifiedBy>Upadhyaya, Narayana (Agriculture, Black Mountain)</cp:lastModifiedBy>
  <cp:revision>19</cp:revision>
  <dcterms:created xsi:type="dcterms:W3CDTF">2014-05-06T00:27:02Z</dcterms:created>
  <dcterms:modified xsi:type="dcterms:W3CDTF">2014-09-29T11:01:43Z</dcterms:modified>
</cp:coreProperties>
</file>